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34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38375654119628"/>
          <c:y val="0.19203488408585209"/>
          <c:w val="0.80163694303324295"/>
          <c:h val="0.63527665146669765"/>
        </c:manualLayout>
      </c:layout>
      <c:scatterChart>
        <c:scatterStyle val="lineMarker"/>
        <c:varyColors val="0"/>
        <c:ser>
          <c:idx val="0"/>
          <c:order val="0"/>
          <c:tx>
            <c:strRef>
              <c:f>'p202-plots'!$B$1</c:f>
              <c:strCache>
                <c:ptCount val="1"/>
                <c:pt idx="0">
                  <c:v>Comparisons - age (after removing the first 5 years of FU) 60-69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xVal>
            <c:numRef>
              <c:f>'p202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2-plots'!$B$2:$B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80999999999998</c:v>
                </c:pt>
                <c:pt idx="3">
                  <c:v>0.99980999999999998</c:v>
                </c:pt>
                <c:pt idx="4">
                  <c:v>0.99887000000000004</c:v>
                </c:pt>
                <c:pt idx="5">
                  <c:v>0.99887000000000004</c:v>
                </c:pt>
                <c:pt idx="6">
                  <c:v>0.99629999999999996</c:v>
                </c:pt>
                <c:pt idx="7">
                  <c:v>0.99629999999999996</c:v>
                </c:pt>
                <c:pt idx="8">
                  <c:v>0.99209000000000003</c:v>
                </c:pt>
                <c:pt idx="9">
                  <c:v>0.99209000000000003</c:v>
                </c:pt>
                <c:pt idx="10">
                  <c:v>0.98673999999999995</c:v>
                </c:pt>
                <c:pt idx="11">
                  <c:v>0.98673999999999995</c:v>
                </c:pt>
                <c:pt idx="12">
                  <c:v>0.97997000000000001</c:v>
                </c:pt>
                <c:pt idx="13">
                  <c:v>0.97997000000000001</c:v>
                </c:pt>
                <c:pt idx="14">
                  <c:v>0.97275999999999996</c:v>
                </c:pt>
                <c:pt idx="15">
                  <c:v>0.97275999999999996</c:v>
                </c:pt>
                <c:pt idx="16">
                  <c:v>0.96545000000000003</c:v>
                </c:pt>
                <c:pt idx="17">
                  <c:v>0.96545000000000003</c:v>
                </c:pt>
                <c:pt idx="18">
                  <c:v>0.95772000000000002</c:v>
                </c:pt>
                <c:pt idx="19">
                  <c:v>0.95772000000000002</c:v>
                </c:pt>
                <c:pt idx="20">
                  <c:v>0.94999</c:v>
                </c:pt>
                <c:pt idx="21">
                  <c:v>0.94999</c:v>
                </c:pt>
                <c:pt idx="22">
                  <c:v>0.94044000000000005</c:v>
                </c:pt>
                <c:pt idx="23">
                  <c:v>0.94044000000000005</c:v>
                </c:pt>
                <c:pt idx="24">
                  <c:v>0.93303999999999998</c:v>
                </c:pt>
                <c:pt idx="25">
                  <c:v>0.93303999999999998</c:v>
                </c:pt>
                <c:pt idx="26">
                  <c:v>0.91959000000000002</c:v>
                </c:pt>
                <c:pt idx="27">
                  <c:v>0.91959000000000002</c:v>
                </c:pt>
                <c:pt idx="28">
                  <c:v>0.9121700000000000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B9B-431D-B932-66B0E66CA879}"/>
            </c:ext>
          </c:extLst>
        </c:ser>
        <c:ser>
          <c:idx val="1"/>
          <c:order val="1"/>
          <c:tx>
            <c:strRef>
              <c:f>'p202-plots'!$C$1</c:f>
              <c:strCache>
                <c:ptCount val="1"/>
              </c:strCache>
            </c:strRef>
          </c:tx>
          <c:spPr>
            <a:ln w="22225" cap="rnd">
              <a:solidFill>
                <a:schemeClr val="accent2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2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2-plots'!$C$2:$C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68999999999997</c:v>
                </c:pt>
                <c:pt idx="3">
                  <c:v>0.99968999999999997</c:v>
                </c:pt>
                <c:pt idx="4">
                  <c:v>0.99858000000000002</c:v>
                </c:pt>
                <c:pt idx="5">
                  <c:v>0.99858000000000002</c:v>
                </c:pt>
                <c:pt idx="6">
                  <c:v>0.99578</c:v>
                </c:pt>
                <c:pt idx="7">
                  <c:v>0.99578</c:v>
                </c:pt>
                <c:pt idx="8">
                  <c:v>0.99131999999999998</c:v>
                </c:pt>
                <c:pt idx="9">
                  <c:v>0.99131999999999998</c:v>
                </c:pt>
                <c:pt idx="10">
                  <c:v>0.98573</c:v>
                </c:pt>
                <c:pt idx="11">
                  <c:v>0.98573</c:v>
                </c:pt>
                <c:pt idx="12">
                  <c:v>0.97870000000000001</c:v>
                </c:pt>
                <c:pt idx="13">
                  <c:v>0.97870000000000001</c:v>
                </c:pt>
                <c:pt idx="14">
                  <c:v>0.97126000000000001</c:v>
                </c:pt>
                <c:pt idx="15">
                  <c:v>0.97126000000000001</c:v>
                </c:pt>
                <c:pt idx="16">
                  <c:v>0.96372999999999998</c:v>
                </c:pt>
                <c:pt idx="17">
                  <c:v>0.96372999999999998</c:v>
                </c:pt>
                <c:pt idx="18">
                  <c:v>0.95577999999999996</c:v>
                </c:pt>
                <c:pt idx="19">
                  <c:v>0.95577999999999996</c:v>
                </c:pt>
                <c:pt idx="20">
                  <c:v>0.94782</c:v>
                </c:pt>
                <c:pt idx="21">
                  <c:v>0.94782</c:v>
                </c:pt>
                <c:pt idx="22">
                  <c:v>0.93793000000000004</c:v>
                </c:pt>
                <c:pt idx="23">
                  <c:v>0.93793000000000004</c:v>
                </c:pt>
                <c:pt idx="24">
                  <c:v>0.93010000000000004</c:v>
                </c:pt>
                <c:pt idx="25">
                  <c:v>0.93010000000000004</c:v>
                </c:pt>
                <c:pt idx="26">
                  <c:v>0.91491999999999996</c:v>
                </c:pt>
                <c:pt idx="27">
                  <c:v>0.91491999999999996</c:v>
                </c:pt>
                <c:pt idx="28">
                  <c:v>0.9045199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B9B-431D-B932-66B0E66CA879}"/>
            </c:ext>
          </c:extLst>
        </c:ser>
        <c:ser>
          <c:idx val="2"/>
          <c:order val="2"/>
          <c:tx>
            <c:strRef>
              <c:f>'p202-plots'!$D$1</c:f>
              <c:strCache>
                <c:ptCount val="1"/>
              </c:strCache>
            </c:strRef>
          </c:tx>
          <c:spPr>
            <a:ln w="22225" cap="rnd">
              <a:solidFill>
                <a:schemeClr val="accent2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2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2-plots'!$D$2:$D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92999999999999</c:v>
                </c:pt>
                <c:pt idx="3">
                  <c:v>0.99992999999999999</c:v>
                </c:pt>
                <c:pt idx="4">
                  <c:v>0.99916000000000005</c:v>
                </c:pt>
                <c:pt idx="5">
                  <c:v>0.99916000000000005</c:v>
                </c:pt>
                <c:pt idx="6">
                  <c:v>0.99682999999999999</c:v>
                </c:pt>
                <c:pt idx="7">
                  <c:v>0.99682999999999999</c:v>
                </c:pt>
                <c:pt idx="8">
                  <c:v>0.99287000000000003</c:v>
                </c:pt>
                <c:pt idx="9">
                  <c:v>0.99287000000000003</c:v>
                </c:pt>
                <c:pt idx="10">
                  <c:v>0.98775000000000002</c:v>
                </c:pt>
                <c:pt idx="11">
                  <c:v>0.98775000000000002</c:v>
                </c:pt>
                <c:pt idx="12">
                  <c:v>0.98124</c:v>
                </c:pt>
                <c:pt idx="13">
                  <c:v>0.98124</c:v>
                </c:pt>
                <c:pt idx="14">
                  <c:v>0.97426000000000001</c:v>
                </c:pt>
                <c:pt idx="15">
                  <c:v>0.97426000000000001</c:v>
                </c:pt>
                <c:pt idx="16">
                  <c:v>0.96716999999999997</c:v>
                </c:pt>
                <c:pt idx="17">
                  <c:v>0.96716999999999997</c:v>
                </c:pt>
                <c:pt idx="18">
                  <c:v>0.95965999999999996</c:v>
                </c:pt>
                <c:pt idx="19">
                  <c:v>0.95965999999999996</c:v>
                </c:pt>
                <c:pt idx="20">
                  <c:v>0.95216000000000001</c:v>
                </c:pt>
                <c:pt idx="21">
                  <c:v>0.95216000000000001</c:v>
                </c:pt>
                <c:pt idx="22">
                  <c:v>0.94296000000000002</c:v>
                </c:pt>
                <c:pt idx="23">
                  <c:v>0.94296000000000002</c:v>
                </c:pt>
                <c:pt idx="24">
                  <c:v>0.93598000000000003</c:v>
                </c:pt>
                <c:pt idx="25">
                  <c:v>0.93598000000000003</c:v>
                </c:pt>
                <c:pt idx="26">
                  <c:v>0.92427999999999999</c:v>
                </c:pt>
                <c:pt idx="27">
                  <c:v>0.92427999999999999</c:v>
                </c:pt>
                <c:pt idx="28">
                  <c:v>0.919880000000000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3B9B-431D-B932-66B0E66CA879}"/>
            </c:ext>
          </c:extLst>
        </c:ser>
        <c:ser>
          <c:idx val="3"/>
          <c:order val="3"/>
          <c:tx>
            <c:strRef>
              <c:f>'p202-plots'!$E$1</c:f>
              <c:strCache>
                <c:ptCount val="1"/>
                <c:pt idx="0">
                  <c:v>Age at BC 60-69 [p=0.021 compared to comparisons age 60-69]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p202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2-plots'!$E$2:$E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75000000000003</c:v>
                </c:pt>
                <c:pt idx="3">
                  <c:v>0.99975000000000003</c:v>
                </c:pt>
                <c:pt idx="4">
                  <c:v>0.99851000000000001</c:v>
                </c:pt>
                <c:pt idx="5">
                  <c:v>0.99851000000000001</c:v>
                </c:pt>
                <c:pt idx="6">
                  <c:v>0.99514000000000002</c:v>
                </c:pt>
                <c:pt idx="7">
                  <c:v>0.99514000000000002</c:v>
                </c:pt>
                <c:pt idx="8">
                  <c:v>0.98960999999999999</c:v>
                </c:pt>
                <c:pt idx="9">
                  <c:v>0.98960999999999999</c:v>
                </c:pt>
                <c:pt idx="10">
                  <c:v>0.98258999999999996</c:v>
                </c:pt>
                <c:pt idx="11">
                  <c:v>0.98258999999999996</c:v>
                </c:pt>
                <c:pt idx="12">
                  <c:v>0.97372999999999998</c:v>
                </c:pt>
                <c:pt idx="13">
                  <c:v>0.97372999999999998</c:v>
                </c:pt>
                <c:pt idx="14">
                  <c:v>0.96431</c:v>
                </c:pt>
                <c:pt idx="15">
                  <c:v>0.96431</c:v>
                </c:pt>
                <c:pt idx="16">
                  <c:v>0.95479000000000003</c:v>
                </c:pt>
                <c:pt idx="17">
                  <c:v>0.95479000000000003</c:v>
                </c:pt>
                <c:pt idx="18">
                  <c:v>0.94474000000000002</c:v>
                </c:pt>
                <c:pt idx="19">
                  <c:v>0.94474000000000002</c:v>
                </c:pt>
                <c:pt idx="20">
                  <c:v>0.93471000000000004</c:v>
                </c:pt>
                <c:pt idx="21">
                  <c:v>0.93471000000000004</c:v>
                </c:pt>
                <c:pt idx="22">
                  <c:v>0.92237999999999998</c:v>
                </c:pt>
                <c:pt idx="23">
                  <c:v>0.92237999999999998</c:v>
                </c:pt>
                <c:pt idx="24">
                  <c:v>0.91283000000000003</c:v>
                </c:pt>
                <c:pt idx="25">
                  <c:v>0.91283000000000003</c:v>
                </c:pt>
                <c:pt idx="26">
                  <c:v>0.89556000000000002</c:v>
                </c:pt>
                <c:pt idx="27">
                  <c:v>0.89556000000000002</c:v>
                </c:pt>
                <c:pt idx="28">
                  <c:v>0.8860599999999999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3B9B-431D-B932-66B0E66CA879}"/>
            </c:ext>
          </c:extLst>
        </c:ser>
        <c:ser>
          <c:idx val="4"/>
          <c:order val="4"/>
          <c:tx>
            <c:strRef>
              <c:f>'p202-plots'!$F$1</c:f>
              <c:strCache>
                <c:ptCount val="1"/>
              </c:strCache>
            </c:strRef>
          </c:tx>
          <c:spPr>
            <a:ln w="22225" cap="rnd">
              <a:solidFill>
                <a:schemeClr val="accent1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2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2-plots'!$F$2:$F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58999999999998</c:v>
                </c:pt>
                <c:pt idx="3">
                  <c:v>0.99958999999999998</c:v>
                </c:pt>
                <c:pt idx="4">
                  <c:v>0.99805999999999995</c:v>
                </c:pt>
                <c:pt idx="5">
                  <c:v>0.99805999999999995</c:v>
                </c:pt>
                <c:pt idx="6">
                  <c:v>0.99407000000000001</c:v>
                </c:pt>
                <c:pt idx="7">
                  <c:v>0.99407000000000001</c:v>
                </c:pt>
                <c:pt idx="8">
                  <c:v>0.98760000000000003</c:v>
                </c:pt>
                <c:pt idx="9">
                  <c:v>0.98760000000000003</c:v>
                </c:pt>
                <c:pt idx="10">
                  <c:v>0.97940000000000005</c:v>
                </c:pt>
                <c:pt idx="11">
                  <c:v>0.97940000000000005</c:v>
                </c:pt>
                <c:pt idx="12">
                  <c:v>0.96906999999999999</c:v>
                </c:pt>
                <c:pt idx="13">
                  <c:v>0.96906999999999999</c:v>
                </c:pt>
                <c:pt idx="14">
                  <c:v>0.95811999999999997</c:v>
                </c:pt>
                <c:pt idx="15">
                  <c:v>0.95811999999999997</c:v>
                </c:pt>
                <c:pt idx="16">
                  <c:v>0.94704999999999995</c:v>
                </c:pt>
                <c:pt idx="17">
                  <c:v>0.94704999999999995</c:v>
                </c:pt>
                <c:pt idx="18">
                  <c:v>0.93539000000000005</c:v>
                </c:pt>
                <c:pt idx="19">
                  <c:v>0.93539000000000005</c:v>
                </c:pt>
                <c:pt idx="20">
                  <c:v>0.92376999999999998</c:v>
                </c:pt>
                <c:pt idx="21">
                  <c:v>0.92376999999999998</c:v>
                </c:pt>
                <c:pt idx="22">
                  <c:v>0.90949999999999998</c:v>
                </c:pt>
                <c:pt idx="23">
                  <c:v>0.90949999999999998</c:v>
                </c:pt>
                <c:pt idx="24">
                  <c:v>0.89847999999999995</c:v>
                </c:pt>
                <c:pt idx="25">
                  <c:v>0.89847999999999995</c:v>
                </c:pt>
                <c:pt idx="26">
                  <c:v>0.87849999999999995</c:v>
                </c:pt>
                <c:pt idx="27">
                  <c:v>0.87849999999999995</c:v>
                </c:pt>
                <c:pt idx="28">
                  <c:v>0.8670600000000000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3B9B-431D-B932-66B0E66CA879}"/>
            </c:ext>
          </c:extLst>
        </c:ser>
        <c:ser>
          <c:idx val="5"/>
          <c:order val="5"/>
          <c:tx>
            <c:strRef>
              <c:f>'p202-plots'!$G$1</c:f>
              <c:strCache>
                <c:ptCount val="1"/>
              </c:strCache>
            </c:strRef>
          </c:tx>
          <c:spPr>
            <a:ln w="22225" cap="rnd">
              <a:solidFill>
                <a:schemeClr val="accent1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2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2-plots'!$G$2:$G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90999999999997</c:v>
                </c:pt>
                <c:pt idx="3">
                  <c:v>0.99990999999999997</c:v>
                </c:pt>
                <c:pt idx="4">
                  <c:v>0.99895999999999996</c:v>
                </c:pt>
                <c:pt idx="5">
                  <c:v>0.99895999999999996</c:v>
                </c:pt>
                <c:pt idx="6">
                  <c:v>0.99621000000000004</c:v>
                </c:pt>
                <c:pt idx="7">
                  <c:v>0.99621000000000004</c:v>
                </c:pt>
                <c:pt idx="8">
                  <c:v>0.99161999999999995</c:v>
                </c:pt>
                <c:pt idx="9">
                  <c:v>0.99161999999999995</c:v>
                </c:pt>
                <c:pt idx="10">
                  <c:v>0.98577999999999999</c:v>
                </c:pt>
                <c:pt idx="11">
                  <c:v>0.98577999999999999</c:v>
                </c:pt>
                <c:pt idx="12">
                  <c:v>0.97840000000000005</c:v>
                </c:pt>
                <c:pt idx="13">
                  <c:v>0.97840000000000005</c:v>
                </c:pt>
                <c:pt idx="14">
                  <c:v>0.97055000000000002</c:v>
                </c:pt>
                <c:pt idx="15">
                  <c:v>0.97055000000000002</c:v>
                </c:pt>
                <c:pt idx="16">
                  <c:v>0.96258999999999995</c:v>
                </c:pt>
                <c:pt idx="17">
                  <c:v>0.96258999999999995</c:v>
                </c:pt>
                <c:pt idx="18">
                  <c:v>0.95418000000000003</c:v>
                </c:pt>
                <c:pt idx="19">
                  <c:v>0.95418000000000003</c:v>
                </c:pt>
                <c:pt idx="20">
                  <c:v>0.94577999999999995</c:v>
                </c:pt>
                <c:pt idx="21">
                  <c:v>0.94577999999999995</c:v>
                </c:pt>
                <c:pt idx="22">
                  <c:v>0.93542999999999998</c:v>
                </c:pt>
                <c:pt idx="23">
                  <c:v>0.93542999999999998</c:v>
                </c:pt>
                <c:pt idx="24">
                  <c:v>0.92740999999999996</c:v>
                </c:pt>
                <c:pt idx="25">
                  <c:v>0.92740999999999996</c:v>
                </c:pt>
                <c:pt idx="26">
                  <c:v>0.91295000000000004</c:v>
                </c:pt>
                <c:pt idx="27">
                  <c:v>0.91295000000000004</c:v>
                </c:pt>
                <c:pt idx="28">
                  <c:v>0.9054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3B9B-431D-B932-66B0E66CA8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071808"/>
        <c:axId val="55074112"/>
      </c:scatterChart>
      <c:valAx>
        <c:axId val="55071808"/>
        <c:scaling>
          <c:orientation val="minMax"/>
          <c:max val="14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Follow Up</a:t>
                </a:r>
                <a:r>
                  <a:rPr lang="en-US" sz="1200" baseline="0"/>
                  <a:t> Years</a:t>
                </a:r>
                <a:endParaRPr lang="en-US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074112"/>
        <c:crosses val="autoZero"/>
        <c:crossBetween val="midCat"/>
      </c:valAx>
      <c:valAx>
        <c:axId val="55074112"/>
        <c:scaling>
          <c:orientation val="minMax"/>
          <c:max val="1"/>
          <c:min val="0.70000000000000007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071808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b"/>
      <c:legendEntry>
        <c:idx val="1"/>
        <c:delete val="1"/>
      </c:legendEntry>
      <c:legendEntry>
        <c:idx val="2"/>
        <c:delete val="1"/>
      </c:legendEntry>
      <c:legendEntry>
        <c:idx val="4"/>
        <c:delete val="1"/>
      </c:legendEntry>
      <c:legendEntry>
        <c:idx val="5"/>
        <c:delete val="1"/>
      </c:legendEntry>
      <c:layout>
        <c:manualLayout>
          <c:xMode val="edge"/>
          <c:yMode val="edge"/>
          <c:x val="0.13261238036584147"/>
          <c:y val="0.59613797345602104"/>
          <c:w val="0.61641280612281191"/>
          <c:h val="0.1603911219836744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3049</cdr:x>
      <cdr:y>0.6388</cdr:y>
    </cdr:from>
    <cdr:to>
      <cdr:x>0.74679</cdr:x>
      <cdr:y>0.81815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2A46E6F5-4D14-4231-A938-3E0F2669858D}"/>
            </a:ext>
          </a:extLst>
        </cdr:cNvPr>
        <cdr:cNvSpPr txBox="1"/>
      </cdr:nvSpPr>
      <cdr:spPr>
        <a:xfrm xmlns:a="http://schemas.openxmlformats.org/drawingml/2006/main">
          <a:off x="4956968" y="325675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079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6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422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050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828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066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024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87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006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343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190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E1190-5402-44FD-BE5B-93E39D2801C6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CC41A-4451-4AE7-8924-72A692B59C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68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wpc="http://schemas.microsoft.com/office/word/2010/wordprocessingCanvas" xmlns:mc="http://schemas.openxmlformats.org/markup-compatibility/2006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16="http://schemas.microsoft.com/office/drawing/2014/main" xmlns="" xmlns:xdr="http://schemas.openxmlformats.org/drawingml/2006/spreadsheetDrawing" xmlns:w="http://schemas.openxmlformats.org/wordprocessingml/2006/main" xmlns:w10="urn:schemas-microsoft-com:office:word" xmlns:v="urn:schemas-microsoft-com:vml" xmlns:o="urn:schemas-microsoft-com:office:office" xmlns:lc="http://schemas.openxmlformats.org/drawingml/2006/lockedCanvas" id="{00000000-0008-0000-6A00-000002000000}"/>
              </a:ext>
            </a:extLst>
          </p:cNvPr>
          <p:cNvGraphicFramePr/>
          <p:nvPr/>
        </p:nvGraphicFramePr>
        <p:xfrm>
          <a:off x="1057275" y="1184275"/>
          <a:ext cx="7029450" cy="4489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89782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jpark68</dc:creator>
  <cp:lastModifiedBy>njpark68</cp:lastModifiedBy>
  <cp:revision>1</cp:revision>
  <dcterms:created xsi:type="dcterms:W3CDTF">2017-06-22T09:06:04Z</dcterms:created>
  <dcterms:modified xsi:type="dcterms:W3CDTF">2017-06-22T09:07:10Z</dcterms:modified>
</cp:coreProperties>
</file>